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 Keller" userId="d687773d-cfac-4ad0-9375-f867c23c75e7" providerId="ADAL" clId="{7A972214-BF57-413B-B720-DF26F30A2901}"/>
    <pc:docChg chg="modSld">
      <pc:chgData name="Sara Keller" userId="d687773d-cfac-4ad0-9375-f867c23c75e7" providerId="ADAL" clId="{7A972214-BF57-413B-B720-DF26F30A2901}" dt="2025-11-18T18:56:47.757" v="3" actId="20577"/>
      <pc:docMkLst>
        <pc:docMk/>
      </pc:docMkLst>
      <pc:sldChg chg="modSp mod">
        <pc:chgData name="Sara Keller" userId="d687773d-cfac-4ad0-9375-f867c23c75e7" providerId="ADAL" clId="{7A972214-BF57-413B-B720-DF26F30A2901}" dt="2025-11-18T18:56:47.757" v="3" actId="20577"/>
        <pc:sldMkLst>
          <pc:docMk/>
          <pc:sldMk cId="3100952087" sldId="264"/>
        </pc:sldMkLst>
        <pc:spChg chg="mod">
          <ac:chgData name="Sara Keller" userId="d687773d-cfac-4ad0-9375-f867c23c75e7" providerId="ADAL" clId="{7A972214-BF57-413B-B720-DF26F30A2901}" dt="2025-11-18T18:56:47.757" v="3" actId="20577"/>
          <ac:spMkLst>
            <pc:docMk/>
            <pc:sldMk cId="3100952087" sldId="264"/>
            <ac:spMk id="2" creationId="{3638E527-4D1A-44D1-9A6A-BF527F73B698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oladap2\Downloads\Google%20analytics%204%20(GA4),%20and%20qr%20codes%20scan%20tracking%206.3.25%20%20TEMM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ombo GA dwnlds+LS views+DB vws'!$B$1</c:f>
              <c:strCache>
                <c:ptCount val="1"/>
                <c:pt idx="0">
                  <c:v>Total Web Views (n=4218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combo GA dwnlds+LS views+DB vws'!$A$2:$A$12</c:f>
              <c:numCache>
                <c:formatCode>mmm\-yy</c:formatCode>
                <c:ptCount val="11"/>
                <c:pt idx="0">
                  <c:v>45444</c:v>
                </c:pt>
                <c:pt idx="1">
                  <c:v>45474</c:v>
                </c:pt>
                <c:pt idx="2">
                  <c:v>45505</c:v>
                </c:pt>
                <c:pt idx="3">
                  <c:v>45536</c:v>
                </c:pt>
                <c:pt idx="4">
                  <c:v>45566</c:v>
                </c:pt>
                <c:pt idx="5">
                  <c:v>45597</c:v>
                </c:pt>
                <c:pt idx="6">
                  <c:v>45627</c:v>
                </c:pt>
                <c:pt idx="7">
                  <c:v>45658</c:v>
                </c:pt>
                <c:pt idx="8">
                  <c:v>45689</c:v>
                </c:pt>
                <c:pt idx="9">
                  <c:v>45717</c:v>
                </c:pt>
                <c:pt idx="10">
                  <c:v>45748</c:v>
                </c:pt>
              </c:numCache>
            </c:numRef>
          </c:cat>
          <c:val>
            <c:numRef>
              <c:f>'combo GA dwnlds+LS views+DB vws'!$B$2:$B$12</c:f>
              <c:numCache>
                <c:formatCode>General</c:formatCode>
                <c:ptCount val="11"/>
                <c:pt idx="0">
                  <c:v>81</c:v>
                </c:pt>
                <c:pt idx="1">
                  <c:v>505</c:v>
                </c:pt>
                <c:pt idx="2">
                  <c:v>255</c:v>
                </c:pt>
                <c:pt idx="3">
                  <c:v>210</c:v>
                </c:pt>
                <c:pt idx="4">
                  <c:v>657</c:v>
                </c:pt>
                <c:pt idx="5">
                  <c:v>434</c:v>
                </c:pt>
                <c:pt idx="6">
                  <c:v>326</c:v>
                </c:pt>
                <c:pt idx="7">
                  <c:v>641</c:v>
                </c:pt>
                <c:pt idx="8">
                  <c:v>339</c:v>
                </c:pt>
                <c:pt idx="9">
                  <c:v>318</c:v>
                </c:pt>
                <c:pt idx="10">
                  <c:v>4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282-42F4-9944-50024E824786}"/>
            </c:ext>
          </c:extLst>
        </c:ser>
        <c:ser>
          <c:idx val="1"/>
          <c:order val="1"/>
          <c:tx>
            <c:strRef>
              <c:f>'combo GA dwnlds+LS views+DB vws'!$C$1</c:f>
              <c:strCache>
                <c:ptCount val="1"/>
                <c:pt idx="0">
                  <c:v>Dashboard Views (n=1217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combo GA dwnlds+LS views+DB vws'!$A$2:$A$12</c:f>
              <c:numCache>
                <c:formatCode>mmm\-yy</c:formatCode>
                <c:ptCount val="11"/>
                <c:pt idx="0">
                  <c:v>45444</c:v>
                </c:pt>
                <c:pt idx="1">
                  <c:v>45474</c:v>
                </c:pt>
                <c:pt idx="2">
                  <c:v>45505</c:v>
                </c:pt>
                <c:pt idx="3">
                  <c:v>45536</c:v>
                </c:pt>
                <c:pt idx="4">
                  <c:v>45566</c:v>
                </c:pt>
                <c:pt idx="5">
                  <c:v>45597</c:v>
                </c:pt>
                <c:pt idx="6">
                  <c:v>45627</c:v>
                </c:pt>
                <c:pt idx="7">
                  <c:v>45658</c:v>
                </c:pt>
                <c:pt idx="8">
                  <c:v>45689</c:v>
                </c:pt>
                <c:pt idx="9">
                  <c:v>45717</c:v>
                </c:pt>
                <c:pt idx="10">
                  <c:v>45748</c:v>
                </c:pt>
              </c:numCache>
            </c:numRef>
          </c:cat>
          <c:val>
            <c:numRef>
              <c:f>'combo GA dwnlds+LS views+DB vws'!$C$2:$C$12</c:f>
              <c:numCache>
                <c:formatCode>General</c:formatCode>
                <c:ptCount val="11"/>
                <c:pt idx="0">
                  <c:v>28</c:v>
                </c:pt>
                <c:pt idx="1">
                  <c:v>205</c:v>
                </c:pt>
                <c:pt idx="2">
                  <c:v>43</c:v>
                </c:pt>
                <c:pt idx="3">
                  <c:v>66</c:v>
                </c:pt>
                <c:pt idx="4">
                  <c:v>262</c:v>
                </c:pt>
                <c:pt idx="5">
                  <c:v>148</c:v>
                </c:pt>
                <c:pt idx="6">
                  <c:v>34</c:v>
                </c:pt>
                <c:pt idx="7">
                  <c:v>190</c:v>
                </c:pt>
                <c:pt idx="8">
                  <c:v>46</c:v>
                </c:pt>
                <c:pt idx="9">
                  <c:v>60</c:v>
                </c:pt>
                <c:pt idx="10">
                  <c:v>1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282-42F4-9944-50024E8247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80220703"/>
        <c:axId val="1080219455"/>
      </c:barChart>
      <c:lineChart>
        <c:grouping val="standard"/>
        <c:varyColors val="0"/>
        <c:ser>
          <c:idx val="2"/>
          <c:order val="2"/>
          <c:tx>
            <c:strRef>
              <c:f>'combo GA dwnlds+LS views+DB vws'!$D$1</c:f>
              <c:strCache>
                <c:ptCount val="1"/>
                <c:pt idx="0">
                  <c:v>File Downloads (n=345)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numRef>
              <c:f>'combo GA dwnlds+LS views+DB vws'!$A$2:$A$12</c:f>
              <c:numCache>
                <c:formatCode>mmm\-yy</c:formatCode>
                <c:ptCount val="11"/>
                <c:pt idx="0">
                  <c:v>45444</c:v>
                </c:pt>
                <c:pt idx="1">
                  <c:v>45474</c:v>
                </c:pt>
                <c:pt idx="2">
                  <c:v>45505</c:v>
                </c:pt>
                <c:pt idx="3">
                  <c:v>45536</c:v>
                </c:pt>
                <c:pt idx="4">
                  <c:v>45566</c:v>
                </c:pt>
                <c:pt idx="5">
                  <c:v>45597</c:v>
                </c:pt>
                <c:pt idx="6">
                  <c:v>45627</c:v>
                </c:pt>
                <c:pt idx="7">
                  <c:v>45658</c:v>
                </c:pt>
                <c:pt idx="8">
                  <c:v>45689</c:v>
                </c:pt>
                <c:pt idx="9">
                  <c:v>45717</c:v>
                </c:pt>
                <c:pt idx="10">
                  <c:v>45748</c:v>
                </c:pt>
              </c:numCache>
            </c:numRef>
          </c:cat>
          <c:val>
            <c:numRef>
              <c:f>'combo GA dwnlds+LS views+DB vws'!$D$2:$D$12</c:f>
              <c:numCache>
                <c:formatCode>General</c:formatCode>
                <c:ptCount val="11"/>
                <c:pt idx="0">
                  <c:v>1</c:v>
                </c:pt>
                <c:pt idx="1">
                  <c:v>33</c:v>
                </c:pt>
                <c:pt idx="2">
                  <c:v>17</c:v>
                </c:pt>
                <c:pt idx="3">
                  <c:v>26</c:v>
                </c:pt>
                <c:pt idx="4">
                  <c:v>35</c:v>
                </c:pt>
                <c:pt idx="5">
                  <c:v>29</c:v>
                </c:pt>
                <c:pt idx="6">
                  <c:v>118</c:v>
                </c:pt>
                <c:pt idx="7">
                  <c:v>12</c:v>
                </c:pt>
                <c:pt idx="8">
                  <c:v>52</c:v>
                </c:pt>
                <c:pt idx="9">
                  <c:v>2</c:v>
                </c:pt>
                <c:pt idx="10">
                  <c:v>2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282-42F4-9944-50024E8247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80215295"/>
        <c:axId val="1080214879"/>
      </c:lineChart>
      <c:dateAx>
        <c:axId val="1080220703"/>
        <c:scaling>
          <c:orientation val="minMax"/>
        </c:scaling>
        <c:delete val="0"/>
        <c:axPos val="b"/>
        <c:numFmt formatCode="mmm\-yy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0219455"/>
        <c:crosses val="autoZero"/>
        <c:auto val="1"/>
        <c:lblOffset val="100"/>
        <c:baseTimeUnit val="months"/>
      </c:dateAx>
      <c:valAx>
        <c:axId val="108021945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View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0220703"/>
        <c:crosses val="autoZero"/>
        <c:crossBetween val="between"/>
      </c:valAx>
      <c:valAx>
        <c:axId val="1080214879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ownload Cou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0215295"/>
        <c:crosses val="max"/>
        <c:crossBetween val="between"/>
      </c:valAx>
      <c:dateAx>
        <c:axId val="1080215295"/>
        <c:scaling>
          <c:orientation val="minMax"/>
        </c:scaling>
        <c:delete val="1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Month-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mmm\-yy" sourceLinked="1"/>
        <c:majorTickMark val="out"/>
        <c:minorTickMark val="none"/>
        <c:tickLblPos val="nextTo"/>
        <c:crossAx val="1080214879"/>
        <c:crosses val="autoZero"/>
        <c:auto val="1"/>
        <c:lblOffset val="100"/>
        <c:baseTimeUnit val="months"/>
        <c:majorUnit val="1"/>
        <c:minorUnit val="1"/>
      </c:date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C28A7A-4417-4718-AF81-13D5F3F17A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1B20C8-BBE4-4B4B-9F27-A26085AB74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4072EE-C5AD-437C-B5FB-65F2D3EC1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E2DFDB-3E85-451A-860F-64000ED17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933297-9D22-4BF2-A02C-F2F1F2816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538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7043AF-27DA-47EC-8641-84424DB273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B66133-F925-464F-926E-7FDB40527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0DF7C3-85D3-400F-8A93-8B73ED9C0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34B4F7-D156-4A18-9080-38FFF0C83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C385B7-A34C-4696-9DB3-C1F98B3CC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900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065C3F-E5EC-424B-93F0-EA936BC545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A1A083-3C4B-46EC-B582-761DC3A6DC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918833-B803-4EC1-96EC-AF73AF2F0B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09F59B-C277-443C-A000-A2C90CE2F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03F09E-0A6D-48D2-BE57-261DB65F7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768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F3713B-9C14-45D9-B305-D9643E7C1E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211F58-A986-44A1-8C4F-D7E75F04AB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21035-6232-4D0C-BEFA-6BC2E0852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0FC03D-3683-4E3C-A076-28B3720A3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FCA0E7-DC77-43F6-A53A-97B8BA385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943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EBCA8F-3813-4E62-B553-FC4DFE7FE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2BFE4F-539A-4FEC-B788-2824CB7B26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AD18C0-EC5A-4A2F-B2DF-8933F4B84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66130B-51AB-455D-99C2-66E42B638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F55BF0-4346-4908-AA75-55ED55B65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681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AFF35F-1772-4DBC-B4B6-99E31858A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5D26ED-240A-40C5-987C-7542ECCB43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6437C9-D22B-442F-959A-70E560AECA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61E661-7A41-45D0-B395-B4477B475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1C68C9-7F57-411B-8BD5-6F43639E8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0E6B3A-F36F-41AB-90CA-F824B7875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315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082B23-DA9C-4B54-918F-EB207601C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EDE23C-5BA3-4B27-A4CA-CDB0846A3B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86C5E8-A484-4F7A-BD5E-D07445F72F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4D05CB-DA1D-4F2E-821E-3514155BDE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C930AA-53C5-4504-B850-53E58130CD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557A778-F1EB-4BBD-AB0E-383203794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FC38FB-E3B9-430E-9003-289487E13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6F4543-3AE3-4F8D-99B0-86B10A013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761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91FB27-859C-43AB-9F17-23D1454E0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80F248F-119C-41B8-8DB2-830D0D284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4D2EAC6-BA03-496A-8B66-568C2A78B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B40645-6873-4962-994B-068CEB4F9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850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CE7368-AFF4-4AF6-A2A2-257B806AE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3DD84C5-A425-4FA7-A09A-F703AC735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8EBD6A-DA7E-43BF-AE86-9BA6E6F15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938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2E021B-C94B-4058-9D97-15ECAEC877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84852D-0270-418E-8BC8-84779835C3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1FE1CC-C5EA-4E41-963B-A92374C75A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E15557-75A3-4B94-8D21-5902EAFC5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823396-3441-47CD-AD52-C523B40A17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094A6A-2EB1-4A4B-A0D7-0CA7DBDB2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173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F06D95-BF49-41D2-95B4-4DF971E07E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925EC0-EAA5-486B-92C7-D36BA5FEF0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ACC1AC-06E6-4DB1-9446-72B020AB27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AF3080-7043-4BA9-B3A3-8A034D52B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09C24B-34B4-4721-BF9D-B068DEE3A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EDE8EB-91CB-4242-92BA-F9825CD4D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8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FDBB02-F548-4DFA-A331-67678FEEF5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E7AF09-616F-48B7-9C1A-A09EE61AFF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DC141C-F3B4-4542-8DBD-0EABC4CDE8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B36DA-1048-45A1-8E8E-95A18566E828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21521B-6926-4983-A589-9604C44991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CF288C-A95F-4998-B765-71ADA9A310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73364-6FE8-4A92-95E7-A0838E915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70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38E527-4D1A-44D1-9A6A-BF527F73B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934720"/>
            <a:ext cx="10515600" cy="755968"/>
          </a:xfrm>
        </p:spPr>
        <p:txBody>
          <a:bodyPr/>
          <a:lstStyle/>
          <a:p>
            <a:r>
              <a:rPr lang="en-US" sz="18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pendix 2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bsite and </a:t>
            </a:r>
            <a:r>
              <a:rPr lang="en-US" sz="18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shboard views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toolkit downloads over time</a:t>
            </a:r>
            <a:endParaRPr lang="en-US" dirty="0"/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82CAF6B2-082F-46E4-AF99-07F572DC24BC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00952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ppendix 2: Website and dashboard views and toolkit downloads over tim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pendix 3: Website, dashboard, and toolkit downloads over time</dc:title>
  <dc:creator>Sara Keller</dc:creator>
  <cp:lastModifiedBy>Sara Keller</cp:lastModifiedBy>
  <cp:revision>2</cp:revision>
  <dcterms:created xsi:type="dcterms:W3CDTF">2025-07-16T16:45:15Z</dcterms:created>
  <dcterms:modified xsi:type="dcterms:W3CDTF">2025-11-18T18:56:49Z</dcterms:modified>
</cp:coreProperties>
</file>